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341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0A20BA-E4AF-4D65-999A-A0591BCE575F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8E009-1625-4A99-89E4-3305CEF846A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4125" y="0"/>
            <a:ext cx="22718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upplementary Fig.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09600" y="1600200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图片 5" descr="Fig.1A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73021" y="2300081"/>
            <a:ext cx="3364971" cy="153849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13639" y="2038371"/>
            <a:ext cx="2860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 smtClean="0">
                <a:latin typeface="Arial" pitchFamily="34" charset="0"/>
                <a:cs typeface="Arial" pitchFamily="34" charset="0"/>
              </a:rPr>
              <a:t>Normaspermia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                              SCOS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2090894" y="3774968"/>
            <a:ext cx="28803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363577" y="1600200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图片 9" descr="Fig.1B.jpg"/>
          <p:cNvPicPr>
            <a:picLocks noChangeAspect="1"/>
          </p:cNvPicPr>
          <p:nvPr/>
        </p:nvPicPr>
        <p:blipFill>
          <a:blip r:embed="rId3" cstate="print">
            <a:lum contrast="20000"/>
          </a:blip>
          <a:stretch>
            <a:fillRect/>
          </a:stretch>
        </p:blipFill>
        <p:spPr>
          <a:xfrm>
            <a:off x="4892537" y="2217612"/>
            <a:ext cx="1432063" cy="13716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-5400000">
            <a:off x="3763623" y="2616802"/>
            <a:ext cx="1800200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level</a:t>
            </a:r>
          </a:p>
          <a:p>
            <a:pPr algn="ctr">
              <a:lnSpc>
                <a:spcPts val="13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hsa-miR-320c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-2400000">
            <a:off x="4748040" y="3732805"/>
            <a:ext cx="9246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Normaspermia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 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-2400000">
            <a:off x="5667526" y="3603216"/>
            <a:ext cx="544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SCOS  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5327477" y="2206247"/>
            <a:ext cx="7200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223818" y="1988546"/>
            <a:ext cx="868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&lt; 0.0001 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9600" y="4264223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858271" y="5221224"/>
            <a:ext cx="2757922" cy="534648"/>
            <a:chOff x="3885788" y="4420547"/>
            <a:chExt cx="2757922" cy="534648"/>
          </a:xfrm>
        </p:grpSpPr>
        <p:grpSp>
          <p:nvGrpSpPr>
            <p:cNvPr id="18" name="组合 4"/>
            <p:cNvGrpSpPr/>
            <p:nvPr/>
          </p:nvGrpSpPr>
          <p:grpSpPr>
            <a:xfrm>
              <a:off x="3885788" y="4429124"/>
              <a:ext cx="2757922" cy="523896"/>
              <a:chOff x="3709554" y="4452912"/>
              <a:chExt cx="2757922" cy="523896"/>
            </a:xfrm>
          </p:grpSpPr>
          <p:sp>
            <p:nvSpPr>
              <p:cNvPr id="23" name="矩形 22"/>
              <p:cNvSpPr/>
              <p:nvPr/>
            </p:nvSpPr>
            <p:spPr>
              <a:xfrm>
                <a:off x="4919180" y="4476742"/>
                <a:ext cx="1176803" cy="500066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3709554" y="4452912"/>
                <a:ext cx="275792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200000"/>
                  </a:lnSpc>
                </a:pP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Mature hsa-miR-320c:      5'aaaa </a:t>
                </a:r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gcug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gguu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gaga  </a:t>
                </a:r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ggg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u'3</a:t>
                </a:r>
              </a:p>
              <a:p>
                <a:pPr>
                  <a:lnSpc>
                    <a:spcPct val="200000"/>
                  </a:lnSpc>
                </a:pP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Mature mmu-miR-320-3p:5'aaaa </a:t>
                </a:r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gcug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 </a:t>
                </a:r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gguu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gaga </a:t>
                </a:r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ggg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cga'3</a:t>
                </a:r>
                <a:endParaRPr lang="en-US" sz="7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9" name="直接连接符 18"/>
            <p:cNvCxnSpPr/>
            <p:nvPr/>
          </p:nvCxnSpPr>
          <p:spPr>
            <a:xfrm>
              <a:off x="5163759" y="4420547"/>
              <a:ext cx="0" cy="52322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/>
            <p:cNvCxnSpPr/>
            <p:nvPr/>
          </p:nvCxnSpPr>
          <p:spPr>
            <a:xfrm>
              <a:off x="5638091" y="4431975"/>
              <a:ext cx="0" cy="52322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/>
            <p:cNvCxnSpPr/>
            <p:nvPr/>
          </p:nvCxnSpPr>
          <p:spPr>
            <a:xfrm rot="5400000">
              <a:off x="5385635" y="4711993"/>
              <a:ext cx="0" cy="46800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 rot="5400000">
              <a:off x="5394193" y="4192877"/>
              <a:ext cx="0" cy="46800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34</Words>
  <Application>Microsoft Office PowerPoint</Application>
  <PresentationFormat>全屏显示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5</cp:revision>
  <dcterms:created xsi:type="dcterms:W3CDTF">2017-11-23T03:32:53Z</dcterms:created>
  <dcterms:modified xsi:type="dcterms:W3CDTF">2018-08-13T12:11:29Z</dcterms:modified>
</cp:coreProperties>
</file>